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9" autoAdjust="0"/>
    <p:restoredTop sz="94660"/>
  </p:normalViewPr>
  <p:slideViewPr>
    <p:cSldViewPr snapToGrid="0">
      <p:cViewPr varScale="1">
        <p:scale>
          <a:sx n="72" d="100"/>
          <a:sy n="72" d="100"/>
        </p:scale>
        <p:origin x="12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1BAD82-3501-E595-44B3-EFB8C8C74A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965533-FB1C-28D5-4EC7-2B54867A35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38FDF6-7A42-F90B-9B07-9A6D80954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1883F0-38FC-C41D-7E32-BB61C0900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594E47-812D-1DE0-4C83-C8CC82B26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438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56235-F8C5-B1DE-2C2F-069493D92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ED39D3-609D-988B-4A50-7CE8E408B2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9BC1AB-0E70-6191-131D-FC3141665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F1459C-4C50-D80F-B73A-1F706672D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19060A-1C11-8DE3-C786-1B647265D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65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0E170D-CA88-1C7B-EC18-AE8C1AC53B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164984-1AF3-0068-348A-89717118FE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86AAD2-2649-15FB-3964-F109BA0DB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2CBA54-10C4-B0F8-E8BD-ADAF70439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29AD9-5941-5C4C-ACC3-C824D91F5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5264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88B701-CACC-3CFA-02F3-A786AEC01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BEB3CB-1543-2E7A-4B0D-BCF06F387F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FA442-2B4D-121E-8BB5-32F30849C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D4392-6D31-1F2F-6668-FFF9635DD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FBE9F-EF0F-EC21-235B-67B756F60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095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599C7-E7C9-1541-0790-3EDA4B789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C81515-9331-E2A1-42C7-13AC96FF34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95FAF-E587-2CC2-D736-20A787C72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51100-DF23-1AC5-CFFC-5266DB1F8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A60DF4-72DB-D8B6-2B6A-B229F54D4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669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C2792-E19A-E916-61DA-8B728446B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A56B9C-C9B6-0CD9-048D-767092AA7D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1FC988-0003-6D87-905F-78CFB4A01B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C136BC-7A50-8517-3BCD-B6F816624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00D767-F6E6-50D5-0C51-780D2E1C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81D78B-B239-9FBA-4730-9842295B9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1659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3C491-B8CD-52EB-1411-9C9C7D40A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DF28AA-DADD-2306-9A65-F876D40F1E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84B11B-8F9B-5AE8-8B09-05DEA29D7B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61A369-0D9F-6180-6A7E-03485BCBC3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61DF64-4B44-1292-EB53-76524774E5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782C50-8B92-FFEB-CC64-38C355FFB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E2359D-04F5-3DB1-F531-3392BAFBA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42D273-2A38-10EF-E271-B64A229E0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643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CCF09-B681-11E7-4BEB-B17299456E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72DFD4-E137-D20E-241A-20675689C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204665-3442-B157-CDA3-98AA990ED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FFB599-88B7-248D-B67D-FFB61BB48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873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A886F2-BC86-DD0C-66ED-F1F11E529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E1EE13-F748-37E6-4261-4E41F300D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8A5767-4591-FBF1-4ACA-20A5BB33F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45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1F5D4-ABE9-2F8F-8C87-776CE9707E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04F89D-ED90-50F3-DD5D-C6B9D45C18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9B9473-526A-831E-717F-68D7480A40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7899B0-638A-E9B5-090D-51368164FE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81FE93-56D9-0479-AD24-0BBCC7FB6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A70537-74F5-B618-E096-3277D42744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7274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5D27C-9430-1447-E491-0ECEFCE0B4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5927CE-4F55-166A-B542-0C79FD3FDE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632253-796D-7464-691E-2C4651B5F6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3F532D-95DD-B679-1BCD-4BE81E8C4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343A20-5A7A-5F54-70AB-FE8D50685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40B2D8-4725-B990-9152-F0004BC12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834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F9FD90-5F8C-11C4-4618-1006E9EE3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C916D2-414D-A906-2DAF-BBCF949F3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9E971-D9B7-D4B3-03FA-E0E76D3255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689AC-D280-4EC1-8990-7C20B78EC028}" type="datetimeFigureOut">
              <a:rPr lang="en-GB" smtClean="0"/>
              <a:t>09/1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6B1588-6CB2-49FD-87AF-834102C182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D789C-6873-61B9-5C32-8328087258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B4771-46FF-4773-BD8A-B83AB17D668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4057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998960-9A8B-6AD8-0BBF-A2A06382E3FB}"/>
              </a:ext>
            </a:extLst>
          </p:cNvPr>
          <p:cNvSpPr txBox="1"/>
          <p:nvPr/>
        </p:nvSpPr>
        <p:spPr>
          <a:xfrm>
            <a:off x="145774" y="119270"/>
            <a:ext cx="1689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ource data file </a:t>
            </a:r>
            <a:endParaRPr lang="en-GB" dirty="0"/>
          </a:p>
        </p:txBody>
      </p:sp>
      <p:pic>
        <p:nvPicPr>
          <p:cNvPr id="6" name="Picture 5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0ED70F10-689A-5575-F558-F1AAC3ACDF6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542" b="37260"/>
          <a:stretch/>
        </p:blipFill>
        <p:spPr>
          <a:xfrm>
            <a:off x="1835339" y="1648915"/>
            <a:ext cx="8102636" cy="430268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D8123CF-EBEF-F9E7-FB14-3A9A20639E8E}"/>
              </a:ext>
            </a:extLst>
          </p:cNvPr>
          <p:cNvSpPr txBox="1"/>
          <p:nvPr/>
        </p:nvSpPr>
        <p:spPr>
          <a:xfrm>
            <a:off x="1739900" y="1279583"/>
            <a:ext cx="5606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garose gel image 1 (Extended data Figure 6d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00050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F51ECF-AEDC-1FFE-7121-CB08772788F3}"/>
              </a:ext>
            </a:extLst>
          </p:cNvPr>
          <p:cNvSpPr txBox="1"/>
          <p:nvPr/>
        </p:nvSpPr>
        <p:spPr>
          <a:xfrm>
            <a:off x="145774" y="119270"/>
            <a:ext cx="1689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ource data file 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E439B85-F200-29DE-5C13-6023110576E1}"/>
              </a:ext>
            </a:extLst>
          </p:cNvPr>
          <p:cNvSpPr txBox="1"/>
          <p:nvPr/>
        </p:nvSpPr>
        <p:spPr>
          <a:xfrm>
            <a:off x="1739900" y="1279583"/>
            <a:ext cx="5606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cropped agarose gel image 2 (Extended data Figure 6d)</a:t>
            </a:r>
            <a:endParaRPr lang="en-GB" dirty="0"/>
          </a:p>
        </p:txBody>
      </p:sp>
      <p:pic>
        <p:nvPicPr>
          <p:cNvPr id="7" name="Picture 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EA869B66-79B8-2C98-A78C-609C697A78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2" t="11367" r="56374" b="44444"/>
          <a:stretch/>
        </p:blipFill>
        <p:spPr>
          <a:xfrm>
            <a:off x="2657475" y="1738313"/>
            <a:ext cx="6472238" cy="4865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807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urtney Hanna</dc:creator>
  <cp:lastModifiedBy>Courtney Hanna</cp:lastModifiedBy>
  <cp:revision>1</cp:revision>
  <dcterms:created xsi:type="dcterms:W3CDTF">2022-12-09T15:53:42Z</dcterms:created>
  <dcterms:modified xsi:type="dcterms:W3CDTF">2022-12-09T15:58:29Z</dcterms:modified>
</cp:coreProperties>
</file>